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43" d="100"/>
          <a:sy n="43" d="100"/>
        </p:scale>
        <p:origin x="1598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E2A57-4D04-4726-A3FC-076039359C33}" type="datetimeFigureOut">
              <a:rPr lang="fr-FR" smtClean="0"/>
              <a:t>17/01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1D6EA-6949-4BA8-9383-BB59B7B637B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51081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E2A57-4D04-4726-A3FC-076039359C33}" type="datetimeFigureOut">
              <a:rPr lang="fr-FR" smtClean="0"/>
              <a:t>17/01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1D6EA-6949-4BA8-9383-BB59B7B637B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67356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E2A57-4D04-4726-A3FC-076039359C33}" type="datetimeFigureOut">
              <a:rPr lang="fr-FR" smtClean="0"/>
              <a:t>17/01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1D6EA-6949-4BA8-9383-BB59B7B637B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7605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E2A57-4D04-4726-A3FC-076039359C33}" type="datetimeFigureOut">
              <a:rPr lang="fr-FR" smtClean="0"/>
              <a:t>17/01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1D6EA-6949-4BA8-9383-BB59B7B637B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18460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E2A57-4D04-4726-A3FC-076039359C33}" type="datetimeFigureOut">
              <a:rPr lang="fr-FR" smtClean="0"/>
              <a:t>17/01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1D6EA-6949-4BA8-9383-BB59B7B637B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259144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E2A57-4D04-4726-A3FC-076039359C33}" type="datetimeFigureOut">
              <a:rPr lang="fr-FR" smtClean="0"/>
              <a:t>17/01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1D6EA-6949-4BA8-9383-BB59B7B637B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16834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E2A57-4D04-4726-A3FC-076039359C33}" type="datetimeFigureOut">
              <a:rPr lang="fr-FR" smtClean="0"/>
              <a:t>17/01/2025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1D6EA-6949-4BA8-9383-BB59B7B637B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546878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E2A57-4D04-4726-A3FC-076039359C33}" type="datetimeFigureOut">
              <a:rPr lang="fr-FR" smtClean="0"/>
              <a:t>17/01/2025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1D6EA-6949-4BA8-9383-BB59B7B637B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892636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E2A57-4D04-4726-A3FC-076039359C33}" type="datetimeFigureOut">
              <a:rPr lang="fr-FR" smtClean="0"/>
              <a:t>17/01/2025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1D6EA-6949-4BA8-9383-BB59B7B637B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740399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E2A57-4D04-4726-A3FC-076039359C33}" type="datetimeFigureOut">
              <a:rPr lang="fr-FR" smtClean="0"/>
              <a:t>17/01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1D6EA-6949-4BA8-9383-BB59B7B637B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625927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E2A57-4D04-4726-A3FC-076039359C33}" type="datetimeFigureOut">
              <a:rPr lang="fr-FR" smtClean="0"/>
              <a:t>17/01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1D6EA-6949-4BA8-9383-BB59B7B637B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714146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5E2A57-4D04-4726-A3FC-076039359C33}" type="datetimeFigureOut">
              <a:rPr lang="fr-FR" smtClean="0"/>
              <a:t>17/01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91D6EA-6949-4BA8-9383-BB59B7B637B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623627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Rectangle 19"/>
          <p:cNvSpPr/>
          <p:nvPr/>
        </p:nvSpPr>
        <p:spPr>
          <a:xfrm>
            <a:off x="4999174" y="7331314"/>
            <a:ext cx="3429000" cy="276742"/>
          </a:xfrm>
          <a:prstGeom prst="rect">
            <a:avLst/>
          </a:prstGeom>
        </p:spPr>
        <p:txBody>
          <a:bodyPr>
            <a:spAutoFit/>
          </a:bodyPr>
          <a:lstStyle/>
          <a:p>
            <a:pPr defTabSz="457181"/>
            <a:r>
              <a:rPr lang="fr-FR" sz="599" dirty="0" err="1">
                <a:solidFill>
                  <a:srgbClr val="FF0000"/>
                </a:solidFill>
                <a:latin typeface="Calibri" panose="020F0502020204030204"/>
              </a:rPr>
              <a:t>Everolimus</a:t>
            </a:r>
            <a:r>
              <a:rPr lang="fr-FR" sz="599" dirty="0">
                <a:solidFill>
                  <a:srgbClr val="FF0000"/>
                </a:solidFill>
                <a:latin typeface="Calibri" panose="020F0502020204030204"/>
              </a:rPr>
              <a:t>-endocrine </a:t>
            </a:r>
            <a:r>
              <a:rPr lang="fr-FR" sz="599" dirty="0" err="1">
                <a:solidFill>
                  <a:srgbClr val="FF0000"/>
                </a:solidFill>
                <a:latin typeface="Calibri" panose="020F0502020204030204"/>
              </a:rPr>
              <a:t>therapy</a:t>
            </a:r>
            <a:endParaRPr lang="fr-FR" sz="599" dirty="0">
              <a:solidFill>
                <a:srgbClr val="FF0000"/>
              </a:solidFill>
              <a:latin typeface="Calibri" panose="020F0502020204030204"/>
            </a:endParaRPr>
          </a:p>
          <a:p>
            <a:pPr defTabSz="457181"/>
            <a:r>
              <a:rPr lang="fr-FR" sz="599" dirty="0">
                <a:solidFill>
                  <a:srgbClr val="4472C4">
                    <a:lumMod val="75000"/>
                  </a:srgbClr>
                </a:solidFill>
                <a:latin typeface="Calibri" panose="020F0502020204030204"/>
              </a:rPr>
              <a:t>Placebo-endocrine </a:t>
            </a:r>
            <a:r>
              <a:rPr lang="fr-FR" sz="599" dirty="0" err="1">
                <a:solidFill>
                  <a:srgbClr val="4472C4">
                    <a:lumMod val="75000"/>
                  </a:srgbClr>
                </a:solidFill>
                <a:latin typeface="Calibri" panose="020F0502020204030204"/>
              </a:rPr>
              <a:t>therapy</a:t>
            </a:r>
            <a:endParaRPr lang="fr-FR" sz="599" dirty="0">
              <a:solidFill>
                <a:srgbClr val="4472C4">
                  <a:lumMod val="75000"/>
                </a:srgbClr>
              </a:solidFill>
              <a:latin typeface="Calibri" panose="020F0502020204030204"/>
            </a:endParaRPr>
          </a:p>
        </p:txBody>
      </p:sp>
      <p:grpSp>
        <p:nvGrpSpPr>
          <p:cNvPr id="2" name="Groupe 1"/>
          <p:cNvGrpSpPr/>
          <p:nvPr/>
        </p:nvGrpSpPr>
        <p:grpSpPr>
          <a:xfrm>
            <a:off x="266452" y="925383"/>
            <a:ext cx="6184328" cy="8197572"/>
            <a:chOff x="57447" y="311428"/>
            <a:chExt cx="6184328" cy="8197572"/>
          </a:xfrm>
        </p:grpSpPr>
        <p:sp>
          <p:nvSpPr>
            <p:cNvPr id="6" name="ZoneTexte 5"/>
            <p:cNvSpPr txBox="1"/>
            <p:nvPr/>
          </p:nvSpPr>
          <p:spPr>
            <a:xfrm>
              <a:off x="203362" y="5864913"/>
              <a:ext cx="2968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181"/>
              <a:r>
                <a:rPr lang="fr-FR" dirty="0">
                  <a:solidFill>
                    <a:prstClr val="black"/>
                  </a:solidFill>
                  <a:latin typeface="Calibri" panose="020F0502020204030204"/>
                </a:rPr>
                <a:t>E</a:t>
              </a:r>
            </a:p>
          </p:txBody>
        </p:sp>
        <p:sp>
          <p:nvSpPr>
            <p:cNvPr id="7" name="ZoneTexte 6"/>
            <p:cNvSpPr txBox="1"/>
            <p:nvPr/>
          </p:nvSpPr>
          <p:spPr>
            <a:xfrm>
              <a:off x="3221111" y="5864913"/>
              <a:ext cx="2904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181"/>
              <a:r>
                <a:rPr lang="fr-FR" dirty="0">
                  <a:solidFill>
                    <a:prstClr val="black"/>
                  </a:solidFill>
                  <a:latin typeface="Calibri" panose="020F0502020204030204"/>
                </a:rPr>
                <a:t>F</a:t>
              </a:r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358212" y="311428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181"/>
              <a:r>
                <a:rPr lang="fr-FR" dirty="0">
                  <a:solidFill>
                    <a:prstClr val="black"/>
                  </a:solidFill>
                  <a:latin typeface="Calibri" panose="020F0502020204030204"/>
                </a:rPr>
                <a:t>A</a:t>
              </a:r>
            </a:p>
          </p:txBody>
        </p:sp>
        <p:sp>
          <p:nvSpPr>
            <p:cNvPr id="12" name="ZoneTexte 11"/>
            <p:cNvSpPr txBox="1"/>
            <p:nvPr/>
          </p:nvSpPr>
          <p:spPr>
            <a:xfrm>
              <a:off x="3375961" y="311428"/>
              <a:ext cx="3097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181"/>
              <a:r>
                <a:rPr lang="fr-FR" dirty="0">
                  <a:solidFill>
                    <a:prstClr val="black"/>
                  </a:solidFill>
                  <a:latin typeface="Calibri" panose="020F0502020204030204"/>
                </a:rPr>
                <a:t>B</a:t>
              </a:r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203362" y="2968446"/>
              <a:ext cx="308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181"/>
              <a:r>
                <a:rPr lang="fr-FR" dirty="0">
                  <a:solidFill>
                    <a:prstClr val="black"/>
                  </a:solidFill>
                  <a:latin typeface="Calibri" panose="020F0502020204030204"/>
                </a:rPr>
                <a:t>C</a:t>
              </a:r>
            </a:p>
          </p:txBody>
        </p:sp>
        <p:sp>
          <p:nvSpPr>
            <p:cNvPr id="14" name="ZoneTexte 13"/>
            <p:cNvSpPr txBox="1"/>
            <p:nvPr/>
          </p:nvSpPr>
          <p:spPr>
            <a:xfrm>
              <a:off x="3221111" y="2968446"/>
              <a:ext cx="3273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181"/>
              <a:r>
                <a:rPr lang="fr-FR" dirty="0">
                  <a:solidFill>
                    <a:prstClr val="black"/>
                  </a:solidFill>
                  <a:latin typeface="Calibri" panose="020F0502020204030204"/>
                </a:rPr>
                <a:t>D</a:t>
              </a:r>
            </a:p>
          </p:txBody>
        </p:sp>
        <p:sp>
          <p:nvSpPr>
            <p:cNvPr id="9" name="Rectangle 8"/>
            <p:cNvSpPr/>
            <p:nvPr/>
          </p:nvSpPr>
          <p:spPr>
            <a:xfrm>
              <a:off x="793750" y="8274050"/>
              <a:ext cx="2336800" cy="23495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457181"/>
              <a:endParaRPr lang="fr-FR">
                <a:solidFill>
                  <a:prstClr val="white"/>
                </a:solidFill>
                <a:latin typeface="Calibri" panose="020F0502020204030204"/>
              </a:endParaRPr>
            </a:p>
          </p:txBody>
        </p:sp>
        <p:pic>
          <p:nvPicPr>
            <p:cNvPr id="21" name="Image 20">
              <a:extLst>
                <a:ext uri="{FF2B5EF4-FFF2-40B4-BE49-F238E27FC236}">
                  <a16:creationId xmlns:a16="http://schemas.microsoft.com/office/drawing/2014/main" id="{D300E749-0366-4693-9FF2-C2C7217174C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04470" y="679516"/>
              <a:ext cx="2926080" cy="2194560"/>
            </a:xfrm>
            <a:prstGeom prst="rect">
              <a:avLst/>
            </a:prstGeom>
          </p:spPr>
        </p:pic>
        <p:pic>
          <p:nvPicPr>
            <p:cNvPr id="27" name="Image 26">
              <a:extLst>
                <a:ext uri="{FF2B5EF4-FFF2-40B4-BE49-F238E27FC236}">
                  <a16:creationId xmlns:a16="http://schemas.microsoft.com/office/drawing/2014/main" id="{985DF030-4084-4C67-A828-B931E36F3D6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315695" y="693269"/>
              <a:ext cx="2926080" cy="2194560"/>
            </a:xfrm>
            <a:prstGeom prst="rect">
              <a:avLst/>
            </a:prstGeom>
          </p:spPr>
        </p:pic>
        <p:pic>
          <p:nvPicPr>
            <p:cNvPr id="28" name="Image 27">
              <a:extLst>
                <a:ext uri="{FF2B5EF4-FFF2-40B4-BE49-F238E27FC236}">
                  <a16:creationId xmlns:a16="http://schemas.microsoft.com/office/drawing/2014/main" id="{E9966DA1-5265-49B1-9E84-4BD0EBEE307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7447" y="3552905"/>
              <a:ext cx="2926080" cy="2194560"/>
            </a:xfrm>
            <a:prstGeom prst="rect">
              <a:avLst/>
            </a:prstGeom>
          </p:spPr>
        </p:pic>
        <p:pic>
          <p:nvPicPr>
            <p:cNvPr id="29" name="Image 28">
              <a:extLst>
                <a:ext uri="{FF2B5EF4-FFF2-40B4-BE49-F238E27FC236}">
                  <a16:creationId xmlns:a16="http://schemas.microsoft.com/office/drawing/2014/main" id="{4FDEFC4E-5F8E-4288-99DC-6E003EB1DA8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129442" y="3523129"/>
              <a:ext cx="2926080" cy="2194560"/>
            </a:xfrm>
            <a:prstGeom prst="rect">
              <a:avLst/>
            </a:prstGeom>
          </p:spPr>
        </p:pic>
        <p:pic>
          <p:nvPicPr>
            <p:cNvPr id="30" name="Image 29">
              <a:extLst>
                <a:ext uri="{FF2B5EF4-FFF2-40B4-BE49-F238E27FC236}">
                  <a16:creationId xmlns:a16="http://schemas.microsoft.com/office/drawing/2014/main" id="{3B3A6FBE-8B30-435F-A9F5-422B08A84F4D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96359" y="6215387"/>
              <a:ext cx="2926080" cy="2194560"/>
            </a:xfrm>
            <a:prstGeom prst="rect">
              <a:avLst/>
            </a:prstGeom>
          </p:spPr>
        </p:pic>
        <p:pic>
          <p:nvPicPr>
            <p:cNvPr id="31" name="Image 30">
              <a:extLst>
                <a:ext uri="{FF2B5EF4-FFF2-40B4-BE49-F238E27FC236}">
                  <a16:creationId xmlns:a16="http://schemas.microsoft.com/office/drawing/2014/main" id="{8617614C-5871-43EE-A07C-5F970B24E158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138170" y="6234244"/>
              <a:ext cx="2926080" cy="2194560"/>
            </a:xfrm>
            <a:prstGeom prst="rect">
              <a:avLst/>
            </a:prstGeom>
          </p:spPr>
        </p:pic>
        <p:sp>
          <p:nvSpPr>
            <p:cNvPr id="16" name="ZoneTexte 15"/>
            <p:cNvSpPr txBox="1"/>
            <p:nvPr/>
          </p:nvSpPr>
          <p:spPr>
            <a:xfrm rot="16200000">
              <a:off x="-197914" y="1532118"/>
              <a:ext cx="1055097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defTabSz="457181"/>
              <a:r>
                <a:rPr lang="fr-FR" sz="400" b="1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isease</a:t>
              </a:r>
              <a:r>
                <a:rPr lang="fr-FR" sz="4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free survival </a:t>
              </a:r>
              <a:r>
                <a:rPr lang="fr-FR" sz="400" b="1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robability</a:t>
              </a:r>
              <a:r>
                <a:rPr lang="fr-FR" sz="4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</a:t>
              </a:r>
              <a:endParaRPr lang="fr-FR" sz="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ZoneTexte 16"/>
            <p:cNvSpPr txBox="1"/>
            <p:nvPr/>
          </p:nvSpPr>
          <p:spPr>
            <a:xfrm rot="16200000">
              <a:off x="2911981" y="1532119"/>
              <a:ext cx="1055097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defTabSz="457181"/>
              <a:r>
                <a:rPr lang="fr-FR" sz="400" b="1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isease</a:t>
              </a:r>
              <a:r>
                <a:rPr lang="fr-FR" sz="4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free survival </a:t>
              </a:r>
              <a:r>
                <a:rPr lang="fr-FR" sz="400" b="1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robability</a:t>
              </a:r>
              <a:r>
                <a:rPr lang="fr-FR" sz="4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</a:t>
              </a:r>
              <a:endParaRPr lang="fr-FR" sz="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ZoneTexte 17"/>
            <p:cNvSpPr txBox="1"/>
            <p:nvPr/>
          </p:nvSpPr>
          <p:spPr>
            <a:xfrm rot="16200000">
              <a:off x="2720992" y="4419257"/>
              <a:ext cx="1055097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defTabSz="457181"/>
              <a:r>
                <a:rPr lang="fr-FR" sz="400" b="1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isease</a:t>
              </a:r>
              <a:r>
                <a:rPr lang="fr-FR" sz="4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free survival </a:t>
              </a:r>
              <a:r>
                <a:rPr lang="fr-FR" sz="400" b="1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robability</a:t>
              </a:r>
              <a:r>
                <a:rPr lang="fr-FR" sz="4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</a:t>
              </a:r>
              <a:endParaRPr lang="fr-FR" sz="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ZoneTexte 18"/>
            <p:cNvSpPr txBox="1"/>
            <p:nvPr/>
          </p:nvSpPr>
          <p:spPr>
            <a:xfrm rot="16200000">
              <a:off x="-347040" y="4451279"/>
              <a:ext cx="1055097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defTabSz="457181"/>
              <a:r>
                <a:rPr lang="fr-FR" sz="400" b="1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isease</a:t>
              </a:r>
              <a:r>
                <a:rPr lang="fr-FR" sz="4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free survival </a:t>
              </a:r>
              <a:r>
                <a:rPr lang="fr-FR" sz="400" b="1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robability</a:t>
              </a:r>
              <a:r>
                <a:rPr lang="fr-FR" sz="4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</a:t>
              </a:r>
              <a:endParaRPr lang="fr-FR" sz="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ZoneTexte 21"/>
            <p:cNvSpPr txBox="1"/>
            <p:nvPr/>
          </p:nvSpPr>
          <p:spPr>
            <a:xfrm rot="16200000">
              <a:off x="2734278" y="7067697"/>
              <a:ext cx="1055097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defTabSz="457181"/>
              <a:r>
                <a:rPr lang="fr-FR" sz="400" b="1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isease</a:t>
              </a:r>
              <a:r>
                <a:rPr lang="fr-FR" sz="4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free survival </a:t>
              </a:r>
              <a:r>
                <a:rPr lang="fr-FR" sz="400" b="1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robability</a:t>
              </a:r>
              <a:r>
                <a:rPr lang="fr-FR" sz="4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</a:t>
              </a:r>
              <a:endParaRPr lang="fr-FR" sz="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ZoneTexte 22"/>
            <p:cNvSpPr txBox="1"/>
            <p:nvPr/>
          </p:nvSpPr>
          <p:spPr>
            <a:xfrm rot="16200000">
              <a:off x="-308427" y="7067697"/>
              <a:ext cx="1055097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defTabSz="457181"/>
              <a:r>
                <a:rPr lang="fr-FR" sz="400" b="1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isease</a:t>
              </a:r>
              <a:r>
                <a:rPr lang="fr-FR" sz="4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free survival </a:t>
              </a:r>
              <a:r>
                <a:rPr lang="fr-FR" sz="400" b="1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robability</a:t>
              </a:r>
              <a:r>
                <a:rPr lang="fr-FR" sz="4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</a:t>
              </a:r>
              <a:endParaRPr lang="fr-FR" sz="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ZoneTexte 2"/>
          <p:cNvSpPr txBox="1"/>
          <p:nvPr/>
        </p:nvSpPr>
        <p:spPr>
          <a:xfrm>
            <a:off x="351182" y="339964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Supplementary</a:t>
            </a:r>
            <a:r>
              <a:rPr lang="fr-FR" dirty="0" smtClean="0"/>
              <a:t> Figure 1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377695626"/>
      </p:ext>
    </p:extLst>
  </p:cSld>
  <p:clrMapOvr>
    <a:masterClrMapping/>
  </p:clrMapOvr>
</p:sld>
</file>

<file path=ppt/theme/theme1.xml><?xml version="1.0" encoding="utf-8"?>
<a:theme xmlns:a="http://schemas.openxmlformats.org/drawingml/2006/main" name="1_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</TotalTime>
  <Words>31</Words>
  <Application>Microsoft Office PowerPoint</Application>
  <PresentationFormat>Format A4 (210 x 297 mm)</PresentationFormat>
  <Paragraphs>1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1_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ottu Paul</dc:creator>
  <cp:lastModifiedBy>Cottu Paul</cp:lastModifiedBy>
  <cp:revision>2</cp:revision>
  <dcterms:created xsi:type="dcterms:W3CDTF">2025-01-17T10:00:54Z</dcterms:created>
  <dcterms:modified xsi:type="dcterms:W3CDTF">2025-01-17T10:20:38Z</dcterms:modified>
</cp:coreProperties>
</file>